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AE595D-DAAD-45AC-8669-942446BA70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1E3D06-DDB1-4D9E-AE10-5A32599858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D6BB8E-1096-43A9-A467-0C7E0A3CF43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CD5FF3-6857-4074-8971-F8D5C3E4A92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90E7D4-34DD-4A54-81A7-2CDF8BC221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17C0D-A99C-4A94-9373-CB9F240153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47AA9C-2124-4163-8F09-A6E1BE61E9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3CD3D5-CC77-4513-8730-2C3FEECB11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A88926-7E4B-499D-B628-DB15841439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266F87-F3AB-4F74-8C97-084817278E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89D99A-17E8-417B-8CA5-F1C03B2093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185256-C54F-4A6D-9203-1E5C467563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68AA91-9B4B-4889-A5BF-A55DBE476E71}" type="datetime">
              <a:rPr b="0" lang="zh-CN" sz="1200" spc="-1" strike="noStrike">
                <a:solidFill>
                  <a:srgbClr val="898989"/>
                </a:solidFill>
                <a:latin typeface="Calibri"/>
              </a:rPr>
              <a:t>26/8/29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8D47AC-1D5B-4E27-967D-02D7B807EB8F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直线连接符 1"/>
          <p:cNvSpPr/>
          <p:nvPr/>
        </p:nvSpPr>
        <p:spPr>
          <a:xfrm>
            <a:off x="303120" y="2039760"/>
            <a:ext cx="5112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直线连接符 23"/>
          <p:cNvSpPr/>
          <p:nvPr/>
        </p:nvSpPr>
        <p:spPr>
          <a:xfrm>
            <a:off x="303120" y="3105000"/>
            <a:ext cx="5148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直线连接符 24"/>
          <p:cNvSpPr/>
          <p:nvPr/>
        </p:nvSpPr>
        <p:spPr>
          <a:xfrm>
            <a:off x="303120" y="1557360"/>
            <a:ext cx="5112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文本框 65"/>
          <p:cNvSpPr/>
          <p:nvPr/>
        </p:nvSpPr>
        <p:spPr>
          <a:xfrm>
            <a:off x="-1170000" y="1138320"/>
            <a:ext cx="7996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SUPPLEMENTARY TABLE 10  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微软雅黑"/>
              </a:rPr>
              <a:t>Primer Information (RT-PCR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本框 60"/>
          <p:cNvSpPr/>
          <p:nvPr/>
        </p:nvSpPr>
        <p:spPr>
          <a:xfrm>
            <a:off x="2228760" y="2227320"/>
            <a:ext cx="575964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5′-GGCTAACTAGAGAACCCACTGCTTA-3′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本框 61"/>
          <p:cNvSpPr/>
          <p:nvPr/>
        </p:nvSpPr>
        <p:spPr>
          <a:xfrm>
            <a:off x="622440" y="2232000"/>
            <a:ext cx="14983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MiniRT-F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本框 34"/>
          <p:cNvSpPr/>
          <p:nvPr/>
        </p:nvSpPr>
        <p:spPr>
          <a:xfrm>
            <a:off x="646200" y="1619280"/>
            <a:ext cx="8254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direct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本框 10"/>
          <p:cNvSpPr/>
          <p:nvPr/>
        </p:nvSpPr>
        <p:spPr>
          <a:xfrm>
            <a:off x="3186000" y="1633680"/>
            <a:ext cx="1136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sequenc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30"/>
          <p:cNvSpPr/>
          <p:nvPr/>
        </p:nvSpPr>
        <p:spPr>
          <a:xfrm>
            <a:off x="622440" y="2687760"/>
            <a:ext cx="9777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ABO-RT-R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35"/>
          <p:cNvSpPr/>
          <p:nvPr/>
        </p:nvSpPr>
        <p:spPr>
          <a:xfrm>
            <a:off x="2228760" y="2622600"/>
            <a:ext cx="575964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5′-TTCTTGATGGCAAACACAGTTAACC-3′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8-09T12:44:00Z</dcterms:created>
  <dc:creator>ghl</dc:creator>
  <dc:description/>
  <dc:language>en-US</dc:language>
  <cp:lastModifiedBy>墨铁</cp:lastModifiedBy>
  <dcterms:modified xsi:type="dcterms:W3CDTF">2026-05-25T09:47:11Z</dcterms:modified>
  <cp:revision>57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EF8A1A72F364BE3A5218373BDAA2C6E_13</vt:lpwstr>
  </property>
  <property fmtid="{D5CDD505-2E9C-101B-9397-08002B2CF9AE}" pid="3" name="KSOProductBuildVer">
    <vt:lpwstr>2052-12.1.0.26375</vt:lpwstr>
  </property>
</Properties>
</file>